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F2464-9D33-418C-87EB-5218A3D17F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0E4C1-10BD-42F3-92F8-B459DFEA8D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3E3F5-B97E-401A-9E7C-15D4A7C059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E4BFA-DD1F-4A32-A8D9-EE0B6B16F9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A44DA-80DE-453B-BA40-048464ECED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C368D-1E05-4E34-91B1-0690D79B41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97868-EF68-4703-A5F7-45F75C3CC9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705AE-D783-4EDF-96A8-80AEF659F2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09277-0200-4223-A2D5-2807FEA627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6F633-C68B-4EC4-A612-A833AEA957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A6610-8D83-49EA-9368-B307F3C0C9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4BA60-6A15-464A-A6B0-7D821F3F4E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39B445-6D5E-49DC-8498-282EFC2AA2E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3179160" y="-92520"/>
            <a:ext cx="2785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6"/>
          <p:cNvSpPr/>
          <p:nvPr/>
        </p:nvSpPr>
        <p:spPr>
          <a:xfrm>
            <a:off x="0" y="24638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Bild 1" descr=""/>
          <p:cNvPicPr/>
          <p:nvPr/>
        </p:nvPicPr>
        <p:blipFill>
          <a:blip r:embed="rId1"/>
          <a:stretch/>
        </p:blipFill>
        <p:spPr>
          <a:xfrm>
            <a:off x="0" y="318960"/>
            <a:ext cx="8788320" cy="3060720"/>
          </a:xfrm>
          <a:prstGeom prst="rect">
            <a:avLst/>
          </a:prstGeom>
          <a:ln w="0">
            <a:noFill/>
          </a:ln>
        </p:spPr>
      </p:pic>
      <p:sp>
        <p:nvSpPr>
          <p:cNvPr id="44" name="Rechteck 1"/>
          <p:cNvSpPr/>
          <p:nvPr/>
        </p:nvSpPr>
        <p:spPr>
          <a:xfrm>
            <a:off x="0" y="3379680"/>
            <a:ext cx="8788320" cy="84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 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Myocardial mitochondrial hydrogen peroxide (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emission on malate and succinate after 0, 3 and 8h cold storage time in a) BIOP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reservation buffer compared to b) CUSTODIOL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storage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-way ANOVA. Data are means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Arial"/>
              </a:rPr>
              <a:t>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SEM (n=7/group). **p&lt;0,01 vs. 0/3h CUSTODIO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nd 0/3/8h BIOP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OS, reactive oxygen speci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22T23:09:48Z</dcterms:created>
  <dc:creator>Daniel Scheiber</dc:creator>
  <dc:description/>
  <dc:language>en-US</dc:language>
  <cp:lastModifiedBy>Daniel Scheiber</cp:lastModifiedBy>
  <dcterms:modified xsi:type="dcterms:W3CDTF">2018-03-29T22:51:04Z</dcterms:modified>
  <cp:revision>4</cp:revision>
  <dc:subject/>
  <dc:title>PowerPoint-Präsentation</dc:title>
</cp:coreProperties>
</file>